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079976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AO XL" initials="JX" lastIdx="2" clrIdx="0">
    <p:extLst>
      <p:ext uri="{19B8F6BF-5375-455C-9EA6-DF929625EA0E}">
        <p15:presenceInfo xmlns:p15="http://schemas.microsoft.com/office/powerpoint/2012/main" userId="8e12c6f478ff001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76"/>
    <p:restoredTop sz="94694"/>
  </p:normalViewPr>
  <p:slideViewPr>
    <p:cSldViewPr snapToGrid="0">
      <p:cViewPr varScale="1">
        <p:scale>
          <a:sx n="80" d="100"/>
          <a:sy n="80" d="100"/>
        </p:scale>
        <p:origin x="120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767462"/>
            <a:ext cx="9179799" cy="375991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5672376"/>
            <a:ext cx="8099822" cy="2607442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9401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6453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574987"/>
            <a:ext cx="2328699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574987"/>
            <a:ext cx="6851100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6300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3827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692444"/>
            <a:ext cx="9314796" cy="4492401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7227345"/>
            <a:ext cx="9314796" cy="2362447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6016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874937"/>
            <a:ext cx="4589899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874937"/>
            <a:ext cx="4589899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7845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74990"/>
            <a:ext cx="9314796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647443"/>
            <a:ext cx="4568805" cy="1297471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944914"/>
            <a:ext cx="4568805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647443"/>
            <a:ext cx="4591306" cy="1297471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944914"/>
            <a:ext cx="4591306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366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719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9359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19984"/>
            <a:ext cx="3483205" cy="2519945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554968"/>
            <a:ext cx="5467380" cy="7674832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3239929"/>
            <a:ext cx="3483205" cy="6002369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659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19984"/>
            <a:ext cx="3483205" cy="2519945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554968"/>
            <a:ext cx="5467380" cy="7674832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3239929"/>
            <a:ext cx="3483205" cy="6002369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949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574990"/>
            <a:ext cx="9314796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874937"/>
            <a:ext cx="9314796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0009783"/>
            <a:ext cx="2429947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602EA1-8FFD-482F-8DF7-58D60277505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0009783"/>
            <a:ext cx="364492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0009783"/>
            <a:ext cx="2429947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0F00C9-D145-4C7F-A94A-54A366580A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5276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E6963CA4-C534-48C8-A0BC-D05B7D36B8DF}"/>
              </a:ext>
            </a:extLst>
          </p:cNvPr>
          <p:cNvGrpSpPr/>
          <p:nvPr/>
        </p:nvGrpSpPr>
        <p:grpSpPr>
          <a:xfrm>
            <a:off x="3131359" y="185949"/>
            <a:ext cx="5051258" cy="4551050"/>
            <a:chOff x="3131359" y="185949"/>
            <a:chExt cx="5051258" cy="455105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FEA6CC8F-06CF-4B10-AD49-713E985E04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8" b="5836"/>
            <a:stretch/>
          </p:blipFill>
          <p:spPr>
            <a:xfrm>
              <a:off x="3619901" y="418503"/>
              <a:ext cx="4114800" cy="4120999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58EC0133-752F-4299-9791-C8D21A3C23DE}"/>
                </a:ext>
              </a:extLst>
            </p:cNvPr>
            <p:cNvSpPr txBox="1"/>
            <p:nvPr/>
          </p:nvSpPr>
          <p:spPr>
            <a:xfrm>
              <a:off x="3487652" y="230627"/>
              <a:ext cx="1944763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35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i="1" dirty="0" err="1"/>
                <a:t>Scutellaria</a:t>
              </a:r>
              <a:r>
                <a:rPr lang="en-US" altLang="zh-CN" i="1" dirty="0"/>
                <a:t> baicalensis </a:t>
              </a:r>
              <a:endParaRPr lang="zh-CN" altLang="en-US" i="1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A9B2E86C-B87A-4D7D-8E79-2B4EE2A74896}"/>
                </a:ext>
              </a:extLst>
            </p:cNvPr>
            <p:cNvSpPr txBox="1"/>
            <p:nvPr/>
          </p:nvSpPr>
          <p:spPr>
            <a:xfrm>
              <a:off x="3535231" y="4506167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AD0DEE9-1BF6-4B4D-BDD9-8574503FF89E}"/>
                </a:ext>
              </a:extLst>
            </p:cNvPr>
            <p:cNvSpPr txBox="1"/>
            <p:nvPr/>
          </p:nvSpPr>
          <p:spPr>
            <a:xfrm>
              <a:off x="4140248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05F127C-5CC1-4147-9033-2CC626D8EFD1}"/>
                </a:ext>
              </a:extLst>
            </p:cNvPr>
            <p:cNvSpPr txBox="1"/>
            <p:nvPr/>
          </p:nvSpPr>
          <p:spPr>
            <a:xfrm>
              <a:off x="4578684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6721D02-14F1-4ACF-AF6F-885BBDA32E1B}"/>
                </a:ext>
              </a:extLst>
            </p:cNvPr>
            <p:cNvSpPr txBox="1"/>
            <p:nvPr/>
          </p:nvSpPr>
          <p:spPr>
            <a:xfrm>
              <a:off x="4928779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4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E3960E4-672D-47FF-BD03-B051B3C34A0A}"/>
                </a:ext>
              </a:extLst>
            </p:cNvPr>
            <p:cNvSpPr txBox="1"/>
            <p:nvPr/>
          </p:nvSpPr>
          <p:spPr>
            <a:xfrm>
              <a:off x="5305195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C5579CA-2767-41E1-BB17-26AE23CF25BE}"/>
                </a:ext>
              </a:extLst>
            </p:cNvPr>
            <p:cNvSpPr txBox="1"/>
            <p:nvPr/>
          </p:nvSpPr>
          <p:spPr>
            <a:xfrm>
              <a:off x="5620404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6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C56BBAC-A246-43A0-9B2C-3E7523F4C445}"/>
                </a:ext>
              </a:extLst>
            </p:cNvPr>
            <p:cNvSpPr txBox="1"/>
            <p:nvPr/>
          </p:nvSpPr>
          <p:spPr>
            <a:xfrm>
              <a:off x="5948745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7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28C6A36-7ABE-4201-A323-77E59C900669}"/>
                </a:ext>
              </a:extLst>
            </p:cNvPr>
            <p:cNvSpPr txBox="1"/>
            <p:nvPr/>
          </p:nvSpPr>
          <p:spPr>
            <a:xfrm>
              <a:off x="6256599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8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8B95727-3F43-42C0-AF5E-1CF174B631FE}"/>
                </a:ext>
              </a:extLst>
            </p:cNvPr>
            <p:cNvSpPr txBox="1"/>
            <p:nvPr/>
          </p:nvSpPr>
          <p:spPr>
            <a:xfrm>
              <a:off x="6574536" y="450616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9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C654E75-F827-41A2-AE2C-E332F73410BB}"/>
                </a:ext>
              </a:extLst>
            </p:cNvPr>
            <p:cNvSpPr txBox="1"/>
            <p:nvPr/>
          </p:nvSpPr>
          <p:spPr>
            <a:xfrm>
              <a:off x="3268912" y="3517531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F8A814D2-8EE6-48A8-86CD-007E6DB99AB7}"/>
                </a:ext>
              </a:extLst>
            </p:cNvPr>
            <p:cNvSpPr txBox="1"/>
            <p:nvPr/>
          </p:nvSpPr>
          <p:spPr>
            <a:xfrm>
              <a:off x="3269112" y="4206666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D7C05466-14F7-4E00-99BF-836E1B62541A}"/>
                </a:ext>
              </a:extLst>
            </p:cNvPr>
            <p:cNvSpPr txBox="1"/>
            <p:nvPr/>
          </p:nvSpPr>
          <p:spPr>
            <a:xfrm>
              <a:off x="3266309" y="3023212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7B731F2E-BE56-4283-AB42-876A1DC19693}"/>
                </a:ext>
              </a:extLst>
            </p:cNvPr>
            <p:cNvSpPr txBox="1"/>
            <p:nvPr/>
          </p:nvSpPr>
          <p:spPr>
            <a:xfrm>
              <a:off x="3266309" y="2570507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4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088CE96C-B2E9-48D5-A973-5612CAE5F66A}"/>
                </a:ext>
              </a:extLst>
            </p:cNvPr>
            <p:cNvSpPr txBox="1"/>
            <p:nvPr/>
          </p:nvSpPr>
          <p:spPr>
            <a:xfrm>
              <a:off x="3266309" y="2150711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77D7F417-1B60-4AA5-94A4-5BA8165379FF}"/>
                </a:ext>
              </a:extLst>
            </p:cNvPr>
            <p:cNvSpPr txBox="1"/>
            <p:nvPr/>
          </p:nvSpPr>
          <p:spPr>
            <a:xfrm>
              <a:off x="3272122" y="1760267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6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81CD7A4-5A0B-4920-B1B2-41DC1E6F2AF2}"/>
                </a:ext>
              </a:extLst>
            </p:cNvPr>
            <p:cNvSpPr txBox="1"/>
            <p:nvPr/>
          </p:nvSpPr>
          <p:spPr>
            <a:xfrm>
              <a:off x="3272122" y="143865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7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4B5E2AFA-1DDE-4FF3-BF9D-54F7FBA742CA}"/>
                </a:ext>
              </a:extLst>
            </p:cNvPr>
            <p:cNvSpPr txBox="1"/>
            <p:nvPr/>
          </p:nvSpPr>
          <p:spPr>
            <a:xfrm>
              <a:off x="3266309" y="1139155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8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A306EF40-F23E-4B81-98CC-6991C2241D90}"/>
                </a:ext>
              </a:extLst>
            </p:cNvPr>
            <p:cNvSpPr txBox="1"/>
            <p:nvPr/>
          </p:nvSpPr>
          <p:spPr>
            <a:xfrm>
              <a:off x="3274118" y="838312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i9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1CF0B1FF-7371-4326-A62C-A3A0C08FB68E}"/>
                </a:ext>
              </a:extLst>
            </p:cNvPr>
            <p:cNvSpPr txBox="1"/>
            <p:nvPr/>
          </p:nvSpPr>
          <p:spPr>
            <a:xfrm>
              <a:off x="3131359" y="18594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81DFF680-AC69-6D4D-AF3B-B1A956B01460}"/>
                </a:ext>
              </a:extLst>
            </p:cNvPr>
            <p:cNvSpPr txBox="1"/>
            <p:nvPr/>
          </p:nvSpPr>
          <p:spPr>
            <a:xfrm>
              <a:off x="7132329" y="2047954"/>
              <a:ext cx="105028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35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900" dirty="0"/>
                <a:t>Log</a:t>
              </a:r>
              <a:r>
                <a:rPr lang="en-US" altLang="zh-CN" sz="900" baseline="-25000" dirty="0"/>
                <a:t>2 </a:t>
              </a:r>
              <a:r>
                <a:rPr lang="en-US" altLang="zh-CN" sz="900" dirty="0" smtClean="0"/>
                <a:t>No. of links</a:t>
              </a:r>
              <a:endParaRPr lang="zh-CN" altLang="en-US" sz="900" dirty="0"/>
            </a:p>
          </p:txBody>
        </p: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FE8F0A70-760B-489B-BEDA-40E1DD78282E}"/>
              </a:ext>
            </a:extLst>
          </p:cNvPr>
          <p:cNvGrpSpPr/>
          <p:nvPr/>
        </p:nvGrpSpPr>
        <p:grpSpPr>
          <a:xfrm>
            <a:off x="3209208" y="5106008"/>
            <a:ext cx="5003165" cy="4792191"/>
            <a:chOff x="3209208" y="5106008"/>
            <a:chExt cx="5003165" cy="4792191"/>
          </a:xfrm>
        </p:grpSpPr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F07D75F5-20F2-41F9-A854-8BE3E7DB99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81" b="6697"/>
            <a:stretch/>
          </p:blipFill>
          <p:spPr>
            <a:xfrm>
              <a:off x="3681354" y="5295402"/>
              <a:ext cx="4135420" cy="4170490"/>
            </a:xfrm>
            <a:prstGeom prst="rect">
              <a:avLst/>
            </a:prstGeom>
          </p:spPr>
        </p:pic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059322D7-4818-4631-823D-330CDF6C570A}"/>
                </a:ext>
              </a:extLst>
            </p:cNvPr>
            <p:cNvSpPr txBox="1"/>
            <p:nvPr/>
          </p:nvSpPr>
          <p:spPr>
            <a:xfrm>
              <a:off x="3543000" y="5141511"/>
              <a:ext cx="17267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135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utellaria</a:t>
              </a:r>
              <a:r>
                <a:rPr lang="en-US" altLang="zh-CN" sz="135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35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ta</a:t>
              </a:r>
              <a:r>
                <a:rPr lang="en-US" altLang="zh-CN" sz="135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350" b="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A1E0F9B-3F30-443A-8069-72766544E27C}"/>
                </a:ext>
              </a:extLst>
            </p:cNvPr>
            <p:cNvSpPr txBox="1"/>
            <p:nvPr/>
          </p:nvSpPr>
          <p:spPr>
            <a:xfrm rot="18478424">
              <a:off x="3592843" y="9496684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3FDF421A-A9E6-4BB1-84D6-0DA0D23F9EE4}"/>
                </a:ext>
              </a:extLst>
            </p:cNvPr>
            <p:cNvSpPr txBox="1"/>
            <p:nvPr/>
          </p:nvSpPr>
          <p:spPr>
            <a:xfrm rot="18028839">
              <a:off x="3836308" y="9496685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45762888-3C8B-43DC-8305-F0851406D85A}"/>
                </a:ext>
              </a:extLst>
            </p:cNvPr>
            <p:cNvSpPr txBox="1"/>
            <p:nvPr/>
          </p:nvSpPr>
          <p:spPr>
            <a:xfrm rot="18028839">
              <a:off x="4114630" y="9485081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F3701A7-5910-4476-BD88-CDA1DB9A2256}"/>
                </a:ext>
              </a:extLst>
            </p:cNvPr>
            <p:cNvSpPr txBox="1"/>
            <p:nvPr/>
          </p:nvSpPr>
          <p:spPr>
            <a:xfrm rot="18028839">
              <a:off x="4406506" y="9496686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4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8D148860-DA64-4DDB-B41E-D0D56D4250AF}"/>
                </a:ext>
              </a:extLst>
            </p:cNvPr>
            <p:cNvSpPr txBox="1"/>
            <p:nvPr/>
          </p:nvSpPr>
          <p:spPr>
            <a:xfrm rot="18028839">
              <a:off x="4760455" y="9496686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BB68BD4E-6B28-469C-A500-DD0966AE7527}"/>
                </a:ext>
              </a:extLst>
            </p:cNvPr>
            <p:cNvSpPr txBox="1"/>
            <p:nvPr/>
          </p:nvSpPr>
          <p:spPr>
            <a:xfrm rot="18028839">
              <a:off x="5110552" y="9485081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6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0D5B5F47-FE41-4AF1-9516-46E4CF97A022}"/>
                </a:ext>
              </a:extLst>
            </p:cNvPr>
            <p:cNvSpPr txBox="1"/>
            <p:nvPr/>
          </p:nvSpPr>
          <p:spPr>
            <a:xfrm rot="18028839">
              <a:off x="5344103" y="9496686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7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F7CE2F2D-44FF-4412-8B1A-6ED07E105BFA}"/>
                </a:ext>
              </a:extLst>
            </p:cNvPr>
            <p:cNvSpPr txBox="1"/>
            <p:nvPr/>
          </p:nvSpPr>
          <p:spPr>
            <a:xfrm rot="18028839">
              <a:off x="5513673" y="9504500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8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8485FFD3-3AA2-4B3D-B057-73362E97762D}"/>
                </a:ext>
              </a:extLst>
            </p:cNvPr>
            <p:cNvSpPr txBox="1"/>
            <p:nvPr/>
          </p:nvSpPr>
          <p:spPr>
            <a:xfrm rot="18028839">
              <a:off x="5712774" y="9481060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9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DCFFB2AE-B8CF-4750-B2B7-F3CCD4B082F2}"/>
                </a:ext>
              </a:extLst>
            </p:cNvPr>
            <p:cNvSpPr txBox="1"/>
            <p:nvPr/>
          </p:nvSpPr>
          <p:spPr>
            <a:xfrm rot="18028839">
              <a:off x="5955892" y="950450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0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4B6B24FD-AC96-46C8-8C28-EA18826E619C}"/>
                </a:ext>
              </a:extLst>
            </p:cNvPr>
            <p:cNvSpPr txBox="1"/>
            <p:nvPr/>
          </p:nvSpPr>
          <p:spPr>
            <a:xfrm rot="18028839">
              <a:off x="6171079" y="9496685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48C1629D-5290-45C0-9DD8-B470BF94270E}"/>
                </a:ext>
              </a:extLst>
            </p:cNvPr>
            <p:cNvSpPr txBox="1"/>
            <p:nvPr/>
          </p:nvSpPr>
          <p:spPr>
            <a:xfrm rot="18028839">
              <a:off x="6342231" y="9471298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6E299F12-6ACA-472F-96E9-F0B4445C0763}"/>
                </a:ext>
              </a:extLst>
            </p:cNvPr>
            <p:cNvSpPr txBox="1"/>
            <p:nvPr/>
          </p:nvSpPr>
          <p:spPr>
            <a:xfrm rot="18028839">
              <a:off x="6536404" y="9467927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32DC064D-36D1-4DB7-97FC-757C01FE71FF}"/>
                </a:ext>
              </a:extLst>
            </p:cNvPr>
            <p:cNvSpPr txBox="1"/>
            <p:nvPr/>
          </p:nvSpPr>
          <p:spPr>
            <a:xfrm>
              <a:off x="3217080" y="9125216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E247A7D8-7F0F-4FDC-B0F1-1970FCB3B1C4}"/>
                </a:ext>
              </a:extLst>
            </p:cNvPr>
            <p:cNvSpPr txBox="1"/>
            <p:nvPr/>
          </p:nvSpPr>
          <p:spPr>
            <a:xfrm>
              <a:off x="3217080" y="8879176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32BB0444-7542-44B6-AC74-6DD38567BEDD}"/>
                </a:ext>
              </a:extLst>
            </p:cNvPr>
            <p:cNvSpPr txBox="1"/>
            <p:nvPr/>
          </p:nvSpPr>
          <p:spPr>
            <a:xfrm>
              <a:off x="3217080" y="8525727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0229DF6-5EA0-48C3-BD6A-A3357FE1753C}"/>
                </a:ext>
              </a:extLst>
            </p:cNvPr>
            <p:cNvSpPr txBox="1"/>
            <p:nvPr/>
          </p:nvSpPr>
          <p:spPr>
            <a:xfrm>
              <a:off x="3217080" y="8219563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4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0B1B2858-B8EE-4C07-BC95-8C0949C44C08}"/>
                </a:ext>
              </a:extLst>
            </p:cNvPr>
            <p:cNvSpPr txBox="1"/>
            <p:nvPr/>
          </p:nvSpPr>
          <p:spPr>
            <a:xfrm>
              <a:off x="3214030" y="7762240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5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A6FC401F-5D4D-42A1-8AF7-030BD4DCA079}"/>
                </a:ext>
              </a:extLst>
            </p:cNvPr>
            <p:cNvSpPr txBox="1"/>
            <p:nvPr/>
          </p:nvSpPr>
          <p:spPr>
            <a:xfrm>
              <a:off x="3211614" y="7364744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6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84CF0D75-B427-4B97-93E8-B0AD29FA6FBD}"/>
                </a:ext>
              </a:extLst>
            </p:cNvPr>
            <p:cNvSpPr txBox="1"/>
            <p:nvPr/>
          </p:nvSpPr>
          <p:spPr>
            <a:xfrm>
              <a:off x="3218982" y="7138337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7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366EC3B7-70F0-4B41-8D67-884E0CC38505}"/>
                </a:ext>
              </a:extLst>
            </p:cNvPr>
            <p:cNvSpPr txBox="1"/>
            <p:nvPr/>
          </p:nvSpPr>
          <p:spPr>
            <a:xfrm>
              <a:off x="3218982" y="6893901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8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58CDB669-036A-4184-AED3-E9D4D67F2769}"/>
                </a:ext>
              </a:extLst>
            </p:cNvPr>
            <p:cNvSpPr txBox="1"/>
            <p:nvPr/>
          </p:nvSpPr>
          <p:spPr>
            <a:xfrm>
              <a:off x="3217080" y="6681014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9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FE588E6A-77A0-4D6B-A9DC-2C1B635B348F}"/>
                </a:ext>
              </a:extLst>
            </p:cNvPr>
            <p:cNvSpPr txBox="1"/>
            <p:nvPr/>
          </p:nvSpPr>
          <p:spPr>
            <a:xfrm>
              <a:off x="3209208" y="6270001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0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8CC05313-BD52-4294-AE9C-25ED7F27ECD9}"/>
                </a:ext>
              </a:extLst>
            </p:cNvPr>
            <p:cNvSpPr txBox="1"/>
            <p:nvPr/>
          </p:nvSpPr>
          <p:spPr>
            <a:xfrm>
              <a:off x="3218982" y="6066078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69476CCD-F841-433D-A981-2A9A5C452359}"/>
                </a:ext>
              </a:extLst>
            </p:cNvPr>
            <p:cNvSpPr txBox="1"/>
            <p:nvPr/>
          </p:nvSpPr>
          <p:spPr>
            <a:xfrm>
              <a:off x="3218982" y="5853688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F2027C3C-207E-4D1F-9812-9DF41DF7AEBB}"/>
                </a:ext>
              </a:extLst>
            </p:cNvPr>
            <p:cNvSpPr txBox="1"/>
            <p:nvPr/>
          </p:nvSpPr>
          <p:spPr>
            <a:xfrm>
              <a:off x="3218982" y="565556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bar1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A96152E5-38CE-4531-A3E4-867681BE45BF}"/>
                </a:ext>
              </a:extLst>
            </p:cNvPr>
            <p:cNvSpPr txBox="1"/>
            <p:nvPr/>
          </p:nvSpPr>
          <p:spPr>
            <a:xfrm>
              <a:off x="3218940" y="510600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E2EBB1A7-F927-8348-ABD5-2EBDBB98BF1B}"/>
                </a:ext>
              </a:extLst>
            </p:cNvPr>
            <p:cNvSpPr txBox="1"/>
            <p:nvPr/>
          </p:nvSpPr>
          <p:spPr>
            <a:xfrm>
              <a:off x="7162085" y="6970537"/>
              <a:ext cx="105028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35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900" dirty="0"/>
                <a:t>Log</a:t>
              </a:r>
              <a:r>
                <a:rPr lang="en-US" altLang="zh-CN" sz="900" baseline="-25000" dirty="0"/>
                <a:t>2 </a:t>
              </a:r>
              <a:r>
                <a:rPr lang="en-US" altLang="zh-CN" sz="900" dirty="0" smtClean="0"/>
                <a:t>No. of links</a:t>
              </a:r>
              <a:endParaRPr lang="zh-CN" altLang="en-US" sz="900" dirty="0"/>
            </a:p>
          </p:txBody>
        </p:sp>
      </p:grp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8058D77C-FDCA-41D6-9333-E0802C11C128}"/>
              </a:ext>
            </a:extLst>
          </p:cNvPr>
          <p:cNvCxnSpPr/>
          <p:nvPr/>
        </p:nvCxnSpPr>
        <p:spPr>
          <a:xfrm>
            <a:off x="7290435" y="2308225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45769AF7-9C51-47FE-97C4-EEC40B4BBB40}"/>
              </a:ext>
            </a:extLst>
          </p:cNvPr>
          <p:cNvCxnSpPr/>
          <p:nvPr/>
        </p:nvCxnSpPr>
        <p:spPr>
          <a:xfrm>
            <a:off x="7290435" y="2427605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DE7EE8E2-F3AD-4E96-8918-37B66C666BCF}"/>
              </a:ext>
            </a:extLst>
          </p:cNvPr>
          <p:cNvCxnSpPr/>
          <p:nvPr/>
        </p:nvCxnSpPr>
        <p:spPr>
          <a:xfrm>
            <a:off x="7290435" y="2546985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C5DA6A1D-CAC8-4302-B3A3-6B1A2E17B235}"/>
              </a:ext>
            </a:extLst>
          </p:cNvPr>
          <p:cNvCxnSpPr/>
          <p:nvPr/>
        </p:nvCxnSpPr>
        <p:spPr>
          <a:xfrm>
            <a:off x="7290435" y="2666365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A0776393-E966-404A-81FF-881620742DEC}"/>
              </a:ext>
            </a:extLst>
          </p:cNvPr>
          <p:cNvCxnSpPr/>
          <p:nvPr/>
        </p:nvCxnSpPr>
        <p:spPr>
          <a:xfrm>
            <a:off x="7290435" y="2785745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6BEF0D32-1913-45E4-8B63-4B3CB52D981F}"/>
              </a:ext>
            </a:extLst>
          </p:cNvPr>
          <p:cNvCxnSpPr/>
          <p:nvPr/>
        </p:nvCxnSpPr>
        <p:spPr>
          <a:xfrm>
            <a:off x="7360920" y="7335022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直接连接符 170">
            <a:extLst>
              <a:ext uri="{FF2B5EF4-FFF2-40B4-BE49-F238E27FC236}">
                <a16:creationId xmlns:a16="http://schemas.microsoft.com/office/drawing/2014/main" id="{9C37F6E7-0343-4FA9-B3FE-8173E89EC523}"/>
              </a:ext>
            </a:extLst>
          </p:cNvPr>
          <p:cNvCxnSpPr/>
          <p:nvPr/>
        </p:nvCxnSpPr>
        <p:spPr>
          <a:xfrm>
            <a:off x="7360920" y="7517902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4" name="直接连接符 203">
            <a:extLst>
              <a:ext uri="{FF2B5EF4-FFF2-40B4-BE49-F238E27FC236}">
                <a16:creationId xmlns:a16="http://schemas.microsoft.com/office/drawing/2014/main" id="{3BE9D46A-7296-4E6B-8B18-883896079CC1}"/>
              </a:ext>
            </a:extLst>
          </p:cNvPr>
          <p:cNvCxnSpPr/>
          <p:nvPr/>
        </p:nvCxnSpPr>
        <p:spPr>
          <a:xfrm>
            <a:off x="7356792" y="7695702"/>
            <a:ext cx="476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20142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4</TotalTime>
  <Words>60</Words>
  <Application>Microsoft Office PowerPoint</Application>
  <PresentationFormat>自定义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14</cp:revision>
  <dcterms:created xsi:type="dcterms:W3CDTF">2020-02-20T13:02:17Z</dcterms:created>
  <dcterms:modified xsi:type="dcterms:W3CDTF">2020-10-23T05:56:37Z</dcterms:modified>
</cp:coreProperties>
</file>